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0" r:id="rId2"/>
  </p:sldIdLst>
  <p:sldSz cx="9144000" cy="6858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1" userDrawn="1">
          <p15:clr>
            <a:srgbClr val="A4A3A4"/>
          </p15:clr>
        </p15:guide>
        <p15:guide id="2" pos="2903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FEC2743-248D-62F3-FEB8-BF165DB4503D}" name="さくら 森島" initials="さ森" userId="b27a24ca5985bd24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9" autoAdjust="0"/>
    <p:restoredTop sz="93961" autoAdjust="0"/>
  </p:normalViewPr>
  <p:slideViewPr>
    <p:cSldViewPr snapToGrid="0" showGuides="1">
      <p:cViewPr>
        <p:scale>
          <a:sx n="100" d="100"/>
          <a:sy n="100" d="100"/>
        </p:scale>
        <p:origin x="288" y="48"/>
      </p:cViewPr>
      <p:guideLst>
        <p:guide orient="horz" pos="2251"/>
        <p:guide pos="290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B14D70-4D53-4533-BF47-D4E7E3BB9BEE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9CFD69-C1B2-450A-93D7-7F1AA64EFF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52458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277BA98-4F51-1C5B-E7D3-F743E9EFC8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A980C28-BB59-ECE6-71BA-50329687477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441FB50-7AC4-988D-2A3B-6C5CCEE1303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5B78C03-0241-597B-980E-F956DCF17E1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9CFD69-C1B2-450A-93D7-7F1AA64EFF1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278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195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090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4235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651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792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583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3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997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3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05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957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28F581-6119-438D-991B-46E3D0551420}" type="datetimeFigureOut">
              <a:rPr kumimoji="1" lang="ja-JP" altLang="en-US" smtClean="0"/>
              <a:t>2025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1CEF3-58F0-4773-8283-071A5BD8EB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8498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AEB0CB-1BD1-98B5-CDFF-AAA6EC18A7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772461-BAAE-A86B-7A22-D51D34CD5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7150" y="38101"/>
            <a:ext cx="7898130" cy="251460"/>
          </a:xfrm>
        </p:spPr>
        <p:txBody>
          <a:bodyPr>
            <a:normAutofit fontScale="90000"/>
          </a:bodyPr>
          <a:lstStyle/>
          <a:p>
            <a:r>
              <a:rPr lang="en-US" altLang="ja-JP" sz="1200" dirty="0">
                <a:latin typeface="Calibri 本文"/>
                <a:ea typeface="BIZ UDPゴシック" panose="020B0400000000000000" pitchFamily="50" charset="-128"/>
              </a:rPr>
              <a:t>Table</a:t>
            </a:r>
            <a:r>
              <a:rPr lang="ja-JP" altLang="en-US" sz="1200" dirty="0">
                <a:latin typeface="Calibri 本文"/>
                <a:ea typeface="BIZ UDPゴシック" panose="020B0400000000000000" pitchFamily="50" charset="-128"/>
              </a:rPr>
              <a:t> </a:t>
            </a:r>
            <a:r>
              <a:rPr lang="en-US" altLang="ja-JP" sz="1200">
                <a:latin typeface="Calibri 本文"/>
                <a:ea typeface="BIZ UDPゴシック" panose="020B0400000000000000" pitchFamily="50" charset="-128"/>
              </a:rPr>
              <a:t>S1. </a:t>
            </a:r>
            <a:r>
              <a:rPr lang="en-US" altLang="ja-JP" sz="1200" dirty="0">
                <a:latin typeface="Calibri 本文"/>
                <a:ea typeface="BIZ UDPゴシック" panose="020B0400000000000000" pitchFamily="50" charset="-128"/>
              </a:rPr>
              <a:t>Cutoff value for each marker to detect inborn errors of metabolism.</a:t>
            </a:r>
            <a:endParaRPr kumimoji="1" lang="ja-JP" altLang="en-US" sz="1200" dirty="0">
              <a:latin typeface="Calibri 本文"/>
              <a:ea typeface="BIZ UDPゴシック" panose="020B0400000000000000" pitchFamily="50" charset="-128"/>
            </a:endParaRPr>
          </a:p>
        </p:txBody>
      </p:sp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3336D7B1-56FD-B5A7-C696-2581CAB2940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9663276"/>
              </p:ext>
            </p:extLst>
          </p:nvPr>
        </p:nvGraphicFramePr>
        <p:xfrm>
          <a:off x="104775" y="307039"/>
          <a:ext cx="8723538" cy="483599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77365">
                  <a:extLst>
                    <a:ext uri="{9D8B030D-6E8A-4147-A177-3AD203B41FA5}">
                      <a16:colId xmlns:a16="http://schemas.microsoft.com/office/drawing/2014/main" val="1285162862"/>
                    </a:ext>
                  </a:extLst>
                </a:gridCol>
                <a:gridCol w="3245195">
                  <a:extLst>
                    <a:ext uri="{9D8B030D-6E8A-4147-A177-3AD203B41FA5}">
                      <a16:colId xmlns:a16="http://schemas.microsoft.com/office/drawing/2014/main" val="1060257963"/>
                    </a:ext>
                  </a:extLst>
                </a:gridCol>
                <a:gridCol w="2209636">
                  <a:extLst>
                    <a:ext uri="{9D8B030D-6E8A-4147-A177-3AD203B41FA5}">
                      <a16:colId xmlns:a16="http://schemas.microsoft.com/office/drawing/2014/main" val="1864687268"/>
                    </a:ext>
                  </a:extLst>
                </a:gridCol>
                <a:gridCol w="1491342">
                  <a:extLst>
                    <a:ext uri="{9D8B030D-6E8A-4147-A177-3AD203B41FA5}">
                      <a16:colId xmlns:a16="http://schemas.microsoft.com/office/drawing/2014/main" val="801028758"/>
                    </a:ext>
                  </a:extLst>
                </a:gridCol>
              </a:tblGrid>
              <a:tr h="1829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etabolic disorder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iseas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arker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utoff 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4210121"/>
                  </a:ext>
                </a:extLst>
              </a:tr>
              <a:tr h="356838">
                <a:tc rowSpan="7"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Organic acid metabolism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dirty="0">
                          <a:latin typeface="+mn-lt"/>
                        </a:rPr>
                        <a:t>Methylmalonic acidemia ,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lang="en-US" altLang="ja-JP" sz="1000" dirty="0">
                          <a:latin typeface="+mn-lt"/>
                        </a:rPr>
                        <a:t>Propionic acidem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3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3/C2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3.6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22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5294550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Isovaleric acidem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6201222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3-Methylcrotonyl-CoA carboxylase (MCC) 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-OH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094844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ultipl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arboxylas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-OH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232462"/>
                  </a:ext>
                </a:extLst>
              </a:tr>
              <a:tr h="200707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HMG-CoA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lyas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-OH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0</a:t>
                      </a:r>
                      <a:endParaRPr kumimoji="1" lang="ja-JP" altLang="en-US" sz="1000" b="0" dirty="0">
                        <a:solidFill>
                          <a:srgbClr val="FF0000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5804266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Glutaric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ciduria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typ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1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-DC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2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8979143"/>
                  </a:ext>
                </a:extLst>
              </a:tr>
              <a:tr h="356838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beta-</a:t>
                      </a:r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ketothiolase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-OH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5:1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6528761"/>
                  </a:ext>
                </a:extLst>
              </a:tr>
              <a:tr h="356838">
                <a:tc rowSpan="8"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Fatty acid metabolism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CAD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8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8/C1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30 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.7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4861642"/>
                  </a:ext>
                </a:extLst>
              </a:tr>
              <a:tr h="356838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VLCAD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4:1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4:1/C2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25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013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570891"/>
                  </a:ext>
                </a:extLst>
              </a:tr>
              <a:tr h="356838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Trifunctional protein 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6-OH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8:1-OH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08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05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4884028"/>
                  </a:ext>
                </a:extLst>
              </a:tr>
              <a:tr h="231350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PT1 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0/(C16+C18)</a:t>
                      </a:r>
                      <a:endParaRPr kumimoji="1" lang="ja-JP" altLang="en-US" sz="1000" b="0" dirty="0">
                        <a:solidFill>
                          <a:srgbClr val="FF0000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40</a:t>
                      </a:r>
                      <a:endParaRPr kumimoji="1" lang="ja-JP" altLang="en-US" sz="1000" b="0" dirty="0">
                        <a:solidFill>
                          <a:srgbClr val="FF0000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8051785"/>
                  </a:ext>
                </a:extLst>
              </a:tr>
              <a:tr h="501164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PT2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4/C3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(C16+C18:1)/C2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(C16)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30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50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5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587039"/>
                  </a:ext>
                </a:extLst>
              </a:tr>
              <a:tr h="356838">
                <a:tc vMerge="1">
                  <a:txBody>
                    <a:bodyPr/>
                    <a:lstStyle/>
                    <a:p>
                      <a:endParaRPr kumimoji="1" lang="ja-JP" altLang="en-US" sz="1200" b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ACT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(C16+C18:1)/C2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6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0.55</a:t>
                      </a:r>
                      <a:b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</a:b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5.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8085385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arnitin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eficiency,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systemic primary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lt;7.5</a:t>
                      </a: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5548979"/>
                  </a:ext>
                </a:extLst>
              </a:tr>
              <a:tr h="212512">
                <a:tc vMerge="1">
                  <a:txBody>
                    <a:bodyPr/>
                    <a:lstStyle/>
                    <a:p>
                      <a:endParaRPr kumimoji="1" lang="ja-JP" altLang="en-US" sz="12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Glutaric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ciduria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type 2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8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、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0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、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142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3372293"/>
                  </a:ext>
                </a:extLst>
              </a:tr>
            </a:tbl>
          </a:graphicData>
        </a:graphic>
      </p:graphicFrame>
      <p:graphicFrame>
        <p:nvGraphicFramePr>
          <p:cNvPr id="3" name="コンテンツ プレースホルダー 4">
            <a:extLst>
              <a:ext uri="{FF2B5EF4-FFF2-40B4-BE49-F238E27FC236}">
                <a16:creationId xmlns:a16="http://schemas.microsoft.com/office/drawing/2014/main" id="{B04D81F8-B59C-1D37-FC2B-0C41F445F13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5068525"/>
              </p:ext>
            </p:extLst>
          </p:nvPr>
        </p:nvGraphicFramePr>
        <p:xfrm>
          <a:off x="388854" y="5158396"/>
          <a:ext cx="8580973" cy="14326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93286">
                  <a:extLst>
                    <a:ext uri="{9D8B030D-6E8A-4147-A177-3AD203B41FA5}">
                      <a16:colId xmlns:a16="http://schemas.microsoft.com/office/drawing/2014/main" val="1285162862"/>
                    </a:ext>
                  </a:extLst>
                </a:gridCol>
                <a:gridCol w="3270696">
                  <a:extLst>
                    <a:ext uri="{9D8B030D-6E8A-4147-A177-3AD203B41FA5}">
                      <a16:colId xmlns:a16="http://schemas.microsoft.com/office/drawing/2014/main" val="1060257963"/>
                    </a:ext>
                  </a:extLst>
                </a:gridCol>
                <a:gridCol w="2175928">
                  <a:extLst>
                    <a:ext uri="{9D8B030D-6E8A-4147-A177-3AD203B41FA5}">
                      <a16:colId xmlns:a16="http://schemas.microsoft.com/office/drawing/2014/main" val="1864687268"/>
                    </a:ext>
                  </a:extLst>
                </a:gridCol>
                <a:gridCol w="1641063">
                  <a:extLst>
                    <a:ext uri="{9D8B030D-6E8A-4147-A177-3AD203B41FA5}">
                      <a16:colId xmlns:a16="http://schemas.microsoft.com/office/drawing/2014/main" val="801028758"/>
                    </a:ext>
                  </a:extLst>
                </a:gridCol>
              </a:tblGrid>
              <a:tr h="222361">
                <a:tc rowSpan="6"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mino acid metabolism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Phenylketonur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Ph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12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5294550"/>
                  </a:ext>
                </a:extLst>
              </a:tr>
              <a:tr h="222361">
                <a:tc vMerge="1">
                  <a:txBody>
                    <a:bodyPr/>
                    <a:lstStyle/>
                    <a:p>
                      <a:endParaRPr kumimoji="1" lang="ja-JP" altLang="en-US" sz="11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apl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syrup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urin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diseas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Leu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＋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Ile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35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6201222"/>
                  </a:ext>
                </a:extLst>
              </a:tr>
              <a:tr h="222361">
                <a:tc vMerge="1">
                  <a:txBody>
                    <a:bodyPr/>
                    <a:lstStyle/>
                    <a:p>
                      <a:endParaRPr kumimoji="1" lang="ja-JP" altLang="en-US" sz="11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Homocystinuria</a:t>
                      </a: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e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35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094844"/>
                  </a:ext>
                </a:extLst>
              </a:tr>
              <a:tr h="222361">
                <a:tc vMerge="1">
                  <a:txBody>
                    <a:bodyPr/>
                    <a:lstStyle/>
                    <a:p>
                      <a:endParaRPr kumimoji="1" lang="ja-JP" altLang="en-US" sz="11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itrullinemia type 1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i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60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1232462"/>
                  </a:ext>
                </a:extLst>
              </a:tr>
              <a:tr h="222361">
                <a:tc vMerge="1">
                  <a:txBody>
                    <a:bodyPr/>
                    <a:lstStyle/>
                    <a:p>
                      <a:endParaRPr kumimoji="1" lang="ja-JP" altLang="en-US" sz="11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rgininosuccinic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ciduria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i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&gt;85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5804266"/>
                  </a:ext>
                </a:extLst>
              </a:tr>
              <a:tr h="310696">
                <a:tc vMerge="1">
                  <a:txBody>
                    <a:bodyPr/>
                    <a:lstStyle/>
                    <a:p>
                      <a:endParaRPr kumimoji="1" lang="ja-JP" altLang="en-US" sz="1100" b="0" dirty="0">
                        <a:solidFill>
                          <a:schemeClr val="tx1"/>
                        </a:solidFill>
                        <a:latin typeface="游明朝" panose="02020400000000000000" pitchFamily="18" charset="-128"/>
                        <a:ea typeface="游明朝" panose="02020400000000000000" pitchFamily="18" charset="-128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Glutaric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acidaemia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typ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 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1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381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Cit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、</a:t>
                      </a:r>
                      <a:r>
                        <a:rPr kumimoji="1" lang="en-US" altLang="ja-JP" sz="1000" b="0" dirty="0" err="1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Phe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、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Met</a:t>
                      </a:r>
                      <a:r>
                        <a:rPr kumimoji="1" lang="ja-JP" altLang="en-US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、</a:t>
                      </a:r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+mn-lt"/>
                          <a:ea typeface="BIZ UDPゴシック" panose="020B0400000000000000" pitchFamily="50" charset="-128"/>
                        </a:rPr>
                        <a:t>Tyr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00" b="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+mn-lt"/>
                        <a:ea typeface="BIZ UDPゴシック" panose="020B0400000000000000" pitchFamily="50" charset="-128"/>
                      </a:endParaRPr>
                    </a:p>
                  </a:txBody>
                  <a:tcPr marL="36000" marR="36000" marT="36000" marB="36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89791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250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980</TotalTime>
  <Words>226</Words>
  <Application>Microsoft Office PowerPoint</Application>
  <PresentationFormat>画面に合わせる (4:3)</PresentationFormat>
  <Paragraphs>7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Calibri 本文</vt:lpstr>
      <vt:lpstr>游ゴシック</vt:lpstr>
      <vt:lpstr>Arial</vt:lpstr>
      <vt:lpstr>Calibri</vt:lpstr>
      <vt:lpstr>Calibri Light</vt:lpstr>
      <vt:lpstr>Office テーマ</vt:lpstr>
      <vt:lpstr>Table S1. Cutoff value for each marker to detect inborn errors of metabolism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健二 井原</dc:creator>
  <cp:lastModifiedBy>健二 井原</cp:lastModifiedBy>
  <cp:revision>111</cp:revision>
  <cp:lastPrinted>2025-01-20T23:18:03Z</cp:lastPrinted>
  <dcterms:created xsi:type="dcterms:W3CDTF">2025-01-03T06:49:10Z</dcterms:created>
  <dcterms:modified xsi:type="dcterms:W3CDTF">2025-04-27T06:52:09Z</dcterms:modified>
</cp:coreProperties>
</file>